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486" r:id="rId2"/>
    <p:sldId id="485" r:id="rId3"/>
  </p:sldIdLst>
  <p:sldSz cx="7772400" cy="100584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80000"/>
    <a:srgbClr val="FF7F7F"/>
    <a:srgbClr val="203864"/>
    <a:srgbClr val="5799D5"/>
    <a:srgbClr val="7030A0"/>
    <a:srgbClr val="AA72D4"/>
    <a:srgbClr val="D9D9D9"/>
    <a:srgbClr val="385823"/>
    <a:srgbClr val="9DB4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1" autoAdjust="0"/>
    <p:restoredTop sz="94607" autoAdjust="0"/>
  </p:normalViewPr>
  <p:slideViewPr>
    <p:cSldViewPr snapToGrid="0" showGuides="1">
      <p:cViewPr varScale="1">
        <p:scale>
          <a:sx n="79" d="100"/>
          <a:sy n="79" d="100"/>
        </p:scale>
        <p:origin x="1116" y="90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22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4297-932A-4F71-8903-B6D1F1A62791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B4F4F-841E-4595-8617-427A2B050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796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015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AB7896EC-E3CD-4ADC-ADBD-BCB0E153EB35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3800" y="876300"/>
            <a:ext cx="18288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483" y="3373516"/>
            <a:ext cx="7435436" cy="2760584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015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B60371A-E4C3-41C0-9CCA-55B0B6D9B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35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01" indent="0" algn="ctr">
              <a:buNone/>
              <a:defRPr sz="1700"/>
            </a:lvl2pPr>
            <a:lvl3pPr marL="777202" indent="0" algn="ctr">
              <a:buNone/>
              <a:defRPr sz="1530"/>
            </a:lvl3pPr>
            <a:lvl4pPr marL="1165803" indent="0" algn="ctr">
              <a:buNone/>
              <a:defRPr sz="1360"/>
            </a:lvl4pPr>
            <a:lvl5pPr marL="1554404" indent="0" algn="ctr">
              <a:buNone/>
              <a:defRPr sz="1360"/>
            </a:lvl5pPr>
            <a:lvl6pPr marL="1943005" indent="0" algn="ctr">
              <a:buNone/>
              <a:defRPr sz="1360"/>
            </a:lvl6pPr>
            <a:lvl7pPr marL="2331606" indent="0" algn="ctr">
              <a:buNone/>
              <a:defRPr sz="1360"/>
            </a:lvl7pPr>
            <a:lvl8pPr marL="2720207" indent="0" algn="ctr">
              <a:buNone/>
              <a:defRPr sz="1360"/>
            </a:lvl8pPr>
            <a:lvl9pPr marL="3108808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6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4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2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0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02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03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0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0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60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20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8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7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65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5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81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0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01" indent="0">
              <a:buNone/>
              <a:defRPr sz="2380"/>
            </a:lvl2pPr>
            <a:lvl3pPr marL="777202" indent="0">
              <a:buNone/>
              <a:defRPr sz="2040"/>
            </a:lvl3pPr>
            <a:lvl4pPr marL="1165803" indent="0">
              <a:buNone/>
              <a:defRPr sz="1700"/>
            </a:lvl4pPr>
            <a:lvl5pPr marL="1554404" indent="0">
              <a:buNone/>
              <a:defRPr sz="1700"/>
            </a:lvl5pPr>
            <a:lvl6pPr marL="1943005" indent="0">
              <a:buNone/>
              <a:defRPr sz="1700"/>
            </a:lvl6pPr>
            <a:lvl7pPr marL="2331606" indent="0">
              <a:buNone/>
              <a:defRPr sz="1700"/>
            </a:lvl7pPr>
            <a:lvl8pPr marL="2720207" indent="0">
              <a:buNone/>
              <a:defRPr sz="1700"/>
            </a:lvl8pPr>
            <a:lvl9pPr marL="3108808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2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02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01" indent="-194301" algn="l" defTabSz="777202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02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04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305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5906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508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109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01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02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03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04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05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606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207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808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5313" y="531792"/>
            <a:ext cx="6703695" cy="638196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RGD-modified Ad5 fiber enables efficient transduction of C2C12 myoblasts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schematic representation of the structure of the Ad5 fiber components and how fiber modification alters adenovirus tropism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expressing vectors were generated and equivalent doses of purifie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d5 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d5/RGD viruses were added to confluent C2C12 myoblasts and imaged after 48h. </a:t>
            </a:r>
          </a:p>
        </p:txBody>
      </p:sp>
    </p:spTree>
    <p:extLst>
      <p:ext uri="{BB962C8B-B14F-4D97-AF65-F5344CB8AC3E}">
        <p14:creationId xmlns:p14="http://schemas.microsoft.com/office/powerpoint/2010/main" val="1472567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6842" y="6679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26842" y="37348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="" xmlns:a16="http://schemas.microsoft.com/office/drawing/2014/main" id="{E4BA8CB4-189A-4D48-BFF2-EAB4BE65EF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060" t="60160" r="55081"/>
          <a:stretch/>
        </p:blipFill>
        <p:spPr>
          <a:xfrm>
            <a:off x="765905" y="4986813"/>
            <a:ext cx="2508924" cy="161035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B8BF3128-FFD5-41DD-B145-3A80EBAF5898}"/>
              </a:ext>
            </a:extLst>
          </p:cNvPr>
          <p:cNvSpPr txBox="1"/>
          <p:nvPr/>
        </p:nvSpPr>
        <p:spPr>
          <a:xfrm>
            <a:off x="226842" y="67270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407786AB-3D2A-4D75-AAC4-256A17B106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5904" y="947256"/>
            <a:ext cx="5839519" cy="2728868"/>
          </a:xfrm>
          <a:prstGeom prst="rect">
            <a:avLst/>
          </a:prstGeom>
        </p:spPr>
      </p:pic>
      <p:sp>
        <p:nvSpPr>
          <p:cNvPr id="15" name="Title 1">
            <a:extLst>
              <a:ext uri="{FF2B5EF4-FFF2-40B4-BE49-F238E27FC236}">
                <a16:creationId xmlns="" xmlns:a16="http://schemas.microsoft.com/office/drawing/2014/main" id="{901099CF-95A1-4BFE-BC5F-41846433AAD1}"/>
              </a:ext>
            </a:extLst>
          </p:cNvPr>
          <p:cNvSpPr txBox="1">
            <a:spLocks/>
          </p:cNvSpPr>
          <p:nvPr/>
        </p:nvSpPr>
        <p:spPr>
          <a:xfrm>
            <a:off x="0" y="121958"/>
            <a:ext cx="7772400" cy="63118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Supplemental Figure 3 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386433" y="3941582"/>
            <a:ext cx="6655452" cy="891897"/>
            <a:chOff x="386433" y="4854246"/>
            <a:chExt cx="6655452" cy="891897"/>
          </a:xfrm>
        </p:grpSpPr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E9B19328-758F-4DCD-AA18-F4A9A8542203}"/>
                </a:ext>
              </a:extLst>
            </p:cNvPr>
            <p:cNvSpPr txBox="1"/>
            <p:nvPr/>
          </p:nvSpPr>
          <p:spPr>
            <a:xfrm>
              <a:off x="386433" y="4854246"/>
              <a:ext cx="35904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d5 wild-type fiber CMV-</a:t>
              </a:r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vector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618414" y="5209855"/>
              <a:ext cx="6423471" cy="536288"/>
              <a:chOff x="618414" y="5209855"/>
              <a:chExt cx="6423471" cy="53628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618414" y="5209855"/>
                <a:ext cx="6423471" cy="536288"/>
                <a:chOff x="674464" y="5209247"/>
                <a:chExt cx="6423471" cy="536288"/>
              </a:xfrm>
            </p:grpSpPr>
            <p:sp>
              <p:nvSpPr>
                <p:cNvPr id="25" name="Rectangle 24">
                  <a:extLst>
                    <a:ext uri="{FF2B5EF4-FFF2-40B4-BE49-F238E27FC236}">
                      <a16:creationId xmlns="" xmlns:a16="http://schemas.microsoft.com/office/drawing/2014/main" id="{B945C5D9-5130-42AE-8D85-3DB93DDCAC2C}"/>
                    </a:ext>
                  </a:extLst>
                </p:cNvPr>
                <p:cNvSpPr/>
                <p:nvPr/>
              </p:nvSpPr>
              <p:spPr>
                <a:xfrm>
                  <a:off x="674464" y="5209247"/>
                  <a:ext cx="6423471" cy="536288"/>
                </a:xfrm>
                <a:prstGeom prst="rect">
                  <a:avLst/>
                </a:prstGeom>
                <a:pattFill prst="pct80">
                  <a:fgClr>
                    <a:srgbClr val="203864"/>
                  </a:fgClr>
                  <a:bgClr>
                    <a:srgbClr val="121F36"/>
                  </a:bgClr>
                </a:pattFill>
                <a:ln w="25400">
                  <a:solidFill>
                    <a:srgbClr val="121F3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US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="" xmlns:a16="http://schemas.microsoft.com/office/drawing/2014/main" id="{332DF89D-E4C3-4BF6-9509-D42130E95880}"/>
                    </a:ext>
                  </a:extLst>
                </p:cNvPr>
                <p:cNvSpPr/>
                <p:nvPr/>
              </p:nvSpPr>
              <p:spPr>
                <a:xfrm>
                  <a:off x="1526971" y="5363150"/>
                  <a:ext cx="1005840" cy="228483"/>
                </a:xfrm>
                <a:prstGeom prst="rect">
                  <a:avLst/>
                </a:prstGeom>
                <a:solidFill>
                  <a:srgbClr val="FFC000"/>
                </a:solidFill>
                <a:ln w="254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b="1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r>
                    <a:rPr lang="en-US" sz="1100" b="1" baseline="-25000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pen</a:t>
                  </a:r>
                  <a:endParaRPr 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Right Arrow 32">
                  <a:extLst>
                    <a:ext uri="{FF2B5EF4-FFF2-40B4-BE49-F238E27FC236}">
                      <a16:creationId xmlns="" xmlns:a16="http://schemas.microsoft.com/office/drawing/2014/main" id="{A8F4DCC2-82D1-4033-B939-9FF025635B81}"/>
                    </a:ext>
                  </a:extLst>
                </p:cNvPr>
                <p:cNvSpPr/>
                <p:nvPr/>
              </p:nvSpPr>
              <p:spPr>
                <a:xfrm>
                  <a:off x="775948" y="5290984"/>
                  <a:ext cx="855578" cy="372814"/>
                </a:xfrm>
                <a:prstGeom prst="rightArrow">
                  <a:avLst>
                    <a:gd name="adj1" fmla="val 50000"/>
                    <a:gd name="adj2" fmla="val 72641"/>
                  </a:avLst>
                </a:prstGeom>
                <a:solidFill>
                  <a:srgbClr val="548235"/>
                </a:solidFill>
                <a:ln w="25400">
                  <a:solidFill>
                    <a:schemeClr val="accent6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MV</a:t>
                  </a:r>
                </a:p>
              </p:txBody>
            </p:sp>
            <p:grpSp>
              <p:nvGrpSpPr>
                <p:cNvPr id="2" name="Group 1"/>
                <p:cNvGrpSpPr/>
                <p:nvPr/>
              </p:nvGrpSpPr>
              <p:grpSpPr>
                <a:xfrm>
                  <a:off x="2530295" y="5363137"/>
                  <a:ext cx="1401982" cy="228508"/>
                  <a:chOff x="3978958" y="5224685"/>
                  <a:chExt cx="1401982" cy="228508"/>
                </a:xfrm>
              </p:grpSpPr>
              <p:sp>
                <p:nvSpPr>
                  <p:cNvPr id="21" name="Rectangle 20">
                    <a:extLst>
                      <a:ext uri="{FF2B5EF4-FFF2-40B4-BE49-F238E27FC236}">
                        <a16:creationId xmlns="" xmlns:a16="http://schemas.microsoft.com/office/drawing/2014/main" id="{89D36604-4445-4908-85B6-3981370A93FE}"/>
                      </a:ext>
                    </a:extLst>
                  </p:cNvPr>
                  <p:cNvSpPr/>
                  <p:nvPr/>
                </p:nvSpPr>
                <p:spPr>
                  <a:xfrm>
                    <a:off x="3978958" y="5224710"/>
                    <a:ext cx="749457" cy="228483"/>
                  </a:xfrm>
                  <a:prstGeom prst="rect">
                    <a:avLst/>
                  </a:prstGeom>
                  <a:solidFill>
                    <a:srgbClr val="FF7F7F"/>
                  </a:solidFill>
                  <a:ln w="25400">
                    <a:solidFill>
                      <a:srgbClr val="68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x HA</a:t>
                    </a:r>
                  </a:p>
                </p:txBody>
              </p:sp>
              <p:sp>
                <p:nvSpPr>
                  <p:cNvPr id="22" name="Hexagon 21">
                    <a:extLst>
                      <a:ext uri="{FF2B5EF4-FFF2-40B4-BE49-F238E27FC236}">
                        <a16:creationId xmlns="" xmlns:a16="http://schemas.microsoft.com/office/drawing/2014/main" id="{88A3691B-26BE-4BD8-9A42-1EC087909720}"/>
                      </a:ext>
                    </a:extLst>
                  </p:cNvPr>
                  <p:cNvSpPr/>
                  <p:nvPr/>
                </p:nvSpPr>
                <p:spPr>
                  <a:xfrm>
                    <a:off x="4637342" y="5224685"/>
                    <a:ext cx="743598" cy="228483"/>
                  </a:xfrm>
                  <a:prstGeom prst="hexagon">
                    <a:avLst/>
                  </a:prstGeom>
                  <a:solidFill>
                    <a:srgbClr val="FF7F7F"/>
                  </a:solidFill>
                  <a:ln w="25400">
                    <a:solidFill>
                      <a:srgbClr val="68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b="1" dirty="0" err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lyA</a:t>
                    </a:r>
                    <a:endParaRPr lang="en-US" sz="11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7" name="Rectangle 6"/>
              <p:cNvSpPr/>
              <p:nvPr/>
            </p:nvSpPr>
            <p:spPr>
              <a:xfrm>
                <a:off x="5169309" y="5327669"/>
                <a:ext cx="1179871" cy="300661"/>
              </a:xfrm>
              <a:prstGeom prst="rect">
                <a:avLst/>
              </a:prstGeom>
              <a:solidFill>
                <a:srgbClr val="312F2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5 fiber</a:t>
                </a:r>
              </a:p>
            </p:txBody>
          </p:sp>
        </p:grpSp>
      </p:grpSp>
      <p:grpSp>
        <p:nvGrpSpPr>
          <p:cNvPr id="10" name="Group 9"/>
          <p:cNvGrpSpPr/>
          <p:nvPr/>
        </p:nvGrpSpPr>
        <p:grpSpPr>
          <a:xfrm>
            <a:off x="452393" y="6918315"/>
            <a:ext cx="6589492" cy="936920"/>
            <a:chOff x="452393" y="6030900"/>
            <a:chExt cx="6589492" cy="936920"/>
          </a:xfrm>
        </p:grpSpPr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5417B735-0337-43E5-8DBD-46E24F2B73E7}"/>
                </a:ext>
              </a:extLst>
            </p:cNvPr>
            <p:cNvSpPr txBox="1"/>
            <p:nvPr/>
          </p:nvSpPr>
          <p:spPr>
            <a:xfrm>
              <a:off x="452393" y="6030900"/>
              <a:ext cx="40697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d5/RGD modified fiber CMV-</a:t>
              </a:r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vector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618414" y="6431532"/>
              <a:ext cx="6423471" cy="536288"/>
              <a:chOff x="618414" y="6165708"/>
              <a:chExt cx="6423471" cy="536288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618414" y="6165708"/>
                <a:ext cx="6423471" cy="536288"/>
                <a:chOff x="674464" y="5209247"/>
                <a:chExt cx="6423471" cy="536288"/>
              </a:xfrm>
            </p:grpSpPr>
            <p:sp>
              <p:nvSpPr>
                <p:cNvPr id="27" name="Rectangle 26">
                  <a:extLst>
                    <a:ext uri="{FF2B5EF4-FFF2-40B4-BE49-F238E27FC236}">
                      <a16:creationId xmlns="" xmlns:a16="http://schemas.microsoft.com/office/drawing/2014/main" id="{B945C5D9-5130-42AE-8D85-3DB93DDCAC2C}"/>
                    </a:ext>
                  </a:extLst>
                </p:cNvPr>
                <p:cNvSpPr/>
                <p:nvPr/>
              </p:nvSpPr>
              <p:spPr>
                <a:xfrm>
                  <a:off x="674464" y="5209247"/>
                  <a:ext cx="6423471" cy="536288"/>
                </a:xfrm>
                <a:prstGeom prst="rect">
                  <a:avLst/>
                </a:prstGeom>
                <a:pattFill prst="pct80">
                  <a:fgClr>
                    <a:srgbClr val="203864"/>
                  </a:fgClr>
                  <a:bgClr>
                    <a:srgbClr val="121F36"/>
                  </a:bgClr>
                </a:pattFill>
                <a:ln w="25400">
                  <a:solidFill>
                    <a:srgbClr val="121F3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US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="" xmlns:a16="http://schemas.microsoft.com/office/drawing/2014/main" id="{332DF89D-E4C3-4BF6-9509-D42130E95880}"/>
                    </a:ext>
                  </a:extLst>
                </p:cNvPr>
                <p:cNvSpPr/>
                <p:nvPr/>
              </p:nvSpPr>
              <p:spPr>
                <a:xfrm>
                  <a:off x="1526971" y="5363150"/>
                  <a:ext cx="1005840" cy="228483"/>
                </a:xfrm>
                <a:prstGeom prst="rect">
                  <a:avLst/>
                </a:prstGeom>
                <a:solidFill>
                  <a:srgbClr val="FFC000"/>
                </a:solidFill>
                <a:ln w="254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b="1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r>
                    <a:rPr lang="en-US" sz="1100" b="1" baseline="-25000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pen</a:t>
                  </a:r>
                  <a:endParaRPr lang="en-US" sz="11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ight Arrow 32">
                  <a:extLst>
                    <a:ext uri="{FF2B5EF4-FFF2-40B4-BE49-F238E27FC236}">
                      <a16:creationId xmlns="" xmlns:a16="http://schemas.microsoft.com/office/drawing/2014/main" id="{A8F4DCC2-82D1-4033-B939-9FF025635B81}"/>
                    </a:ext>
                  </a:extLst>
                </p:cNvPr>
                <p:cNvSpPr/>
                <p:nvPr/>
              </p:nvSpPr>
              <p:spPr>
                <a:xfrm>
                  <a:off x="775948" y="5290984"/>
                  <a:ext cx="855578" cy="372814"/>
                </a:xfrm>
                <a:prstGeom prst="rightArrow">
                  <a:avLst>
                    <a:gd name="adj1" fmla="val 50000"/>
                    <a:gd name="adj2" fmla="val 72641"/>
                  </a:avLst>
                </a:prstGeom>
                <a:solidFill>
                  <a:srgbClr val="548235"/>
                </a:solidFill>
                <a:ln w="25400">
                  <a:solidFill>
                    <a:schemeClr val="accent6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MV</a:t>
                  </a:r>
                </a:p>
              </p:txBody>
            </p:sp>
            <p:grpSp>
              <p:nvGrpSpPr>
                <p:cNvPr id="30" name="Group 29"/>
                <p:cNvGrpSpPr/>
                <p:nvPr/>
              </p:nvGrpSpPr>
              <p:grpSpPr>
                <a:xfrm>
                  <a:off x="2530295" y="5363137"/>
                  <a:ext cx="1401982" cy="228508"/>
                  <a:chOff x="3978958" y="5224685"/>
                  <a:chExt cx="1401982" cy="228508"/>
                </a:xfrm>
              </p:grpSpPr>
              <p:sp>
                <p:nvSpPr>
                  <p:cNvPr id="31" name="Rectangle 30">
                    <a:extLst>
                      <a:ext uri="{FF2B5EF4-FFF2-40B4-BE49-F238E27FC236}">
                        <a16:creationId xmlns="" xmlns:a16="http://schemas.microsoft.com/office/drawing/2014/main" id="{89D36604-4445-4908-85B6-3981370A93FE}"/>
                      </a:ext>
                    </a:extLst>
                  </p:cNvPr>
                  <p:cNvSpPr/>
                  <p:nvPr/>
                </p:nvSpPr>
                <p:spPr>
                  <a:xfrm>
                    <a:off x="3978958" y="5224710"/>
                    <a:ext cx="749457" cy="228483"/>
                  </a:xfrm>
                  <a:prstGeom prst="rect">
                    <a:avLst/>
                  </a:prstGeom>
                  <a:solidFill>
                    <a:srgbClr val="FF7F7F"/>
                  </a:solidFill>
                  <a:ln w="25400">
                    <a:solidFill>
                      <a:srgbClr val="68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x HA</a:t>
                    </a:r>
                  </a:p>
                </p:txBody>
              </p:sp>
              <p:sp>
                <p:nvSpPr>
                  <p:cNvPr id="32" name="Hexagon 31">
                    <a:extLst>
                      <a:ext uri="{FF2B5EF4-FFF2-40B4-BE49-F238E27FC236}">
                        <a16:creationId xmlns="" xmlns:a16="http://schemas.microsoft.com/office/drawing/2014/main" id="{88A3691B-26BE-4BD8-9A42-1EC087909720}"/>
                      </a:ext>
                    </a:extLst>
                  </p:cNvPr>
                  <p:cNvSpPr/>
                  <p:nvPr/>
                </p:nvSpPr>
                <p:spPr>
                  <a:xfrm>
                    <a:off x="4637342" y="5224685"/>
                    <a:ext cx="743598" cy="228483"/>
                  </a:xfrm>
                  <a:prstGeom prst="hexagon">
                    <a:avLst/>
                  </a:prstGeom>
                  <a:solidFill>
                    <a:srgbClr val="FF7F7F"/>
                  </a:solidFill>
                  <a:ln w="25400">
                    <a:solidFill>
                      <a:srgbClr val="68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100" b="1" dirty="0" err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lyA</a:t>
                    </a:r>
                    <a:endParaRPr lang="en-US" sz="11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33" name="Rectangle 32"/>
              <p:cNvSpPr/>
              <p:nvPr/>
            </p:nvSpPr>
            <p:spPr>
              <a:xfrm>
                <a:off x="5169309" y="6283522"/>
                <a:ext cx="1179871" cy="300661"/>
              </a:xfrm>
              <a:prstGeom prst="rect">
                <a:avLst/>
              </a:prstGeom>
              <a:solidFill>
                <a:srgbClr val="312F2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d5/RGD fiber</a:t>
                </a:r>
              </a:p>
            </p:txBody>
          </p:sp>
        </p:grpSp>
      </p:grpSp>
      <p:pic>
        <p:nvPicPr>
          <p:cNvPr id="34" name="Picture 33">
            <a:extLst>
              <a:ext uri="{FF2B5EF4-FFF2-40B4-BE49-F238E27FC236}">
                <a16:creationId xmlns="" xmlns:a16="http://schemas.microsoft.com/office/drawing/2014/main" id="{E4BA8CB4-189A-4D48-BFF2-EAB4BE65EF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970" t="60160" r="10140"/>
          <a:stretch/>
        </p:blipFill>
        <p:spPr>
          <a:xfrm>
            <a:off x="712338" y="8049510"/>
            <a:ext cx="2511364" cy="1610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8669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7</TotalTime>
  <Words>98</Words>
  <Application>Microsoft Office PowerPoint</Application>
  <PresentationFormat>Custom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uk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Haldeman</dc:creator>
  <cp:lastModifiedBy>Jonathan Haldeman</cp:lastModifiedBy>
  <cp:revision>627</cp:revision>
  <cp:lastPrinted>2018-11-09T17:51:23Z</cp:lastPrinted>
  <dcterms:created xsi:type="dcterms:W3CDTF">2016-09-16T14:04:00Z</dcterms:created>
  <dcterms:modified xsi:type="dcterms:W3CDTF">2018-11-27T23:39:30Z</dcterms:modified>
</cp:coreProperties>
</file>